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960823C5-79AC-4157-BA04-6C8E5D5B9754}"/>
    <pc:docChg chg="addSld modSld">
      <pc:chgData name="Tekle Pauzaite" userId="06f7e524-8501-4f81-9b2a-484f6f2c7061" providerId="ADAL" clId="{960823C5-79AC-4157-BA04-6C8E5D5B9754}" dt="2024-03-26T14:18:42.186" v="136" actId="571"/>
      <pc:docMkLst>
        <pc:docMk/>
      </pc:docMkLst>
      <pc:sldChg chg="addSp delSp modSp add">
        <pc:chgData name="Tekle Pauzaite" userId="06f7e524-8501-4f81-9b2a-484f6f2c7061" providerId="ADAL" clId="{960823C5-79AC-4157-BA04-6C8E5D5B9754}" dt="2024-03-26T14:18:42.186" v="136" actId="571"/>
        <pc:sldMkLst>
          <pc:docMk/>
          <pc:sldMk cId="1572326335" sldId="256"/>
        </pc:sldMkLst>
        <pc:spChg chg="del">
          <ac:chgData name="Tekle Pauzaite" userId="06f7e524-8501-4f81-9b2a-484f6f2c7061" providerId="ADAL" clId="{960823C5-79AC-4157-BA04-6C8E5D5B9754}" dt="2024-03-26T14:10:18.470" v="1"/>
          <ac:spMkLst>
            <pc:docMk/>
            <pc:sldMk cId="1572326335" sldId="256"/>
            <ac:spMk id="2" creationId="{E22749D3-9114-4C1F-B68C-0140EBAA7093}"/>
          </ac:spMkLst>
        </pc:spChg>
        <pc:spChg chg="del">
          <ac:chgData name="Tekle Pauzaite" userId="06f7e524-8501-4f81-9b2a-484f6f2c7061" providerId="ADAL" clId="{960823C5-79AC-4157-BA04-6C8E5D5B9754}" dt="2024-03-26T14:10:18.470" v="1"/>
          <ac:spMkLst>
            <pc:docMk/>
            <pc:sldMk cId="1572326335" sldId="256"/>
            <ac:spMk id="3" creationId="{30FFB631-740D-4F27-8EC5-2853FF76EB78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4" creationId="{2F92CD2F-50F4-4CC8-9DCB-BC0ED022E07E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5" creationId="{0CE59D3F-E750-422A-B1C8-11567EC8BB38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6" creationId="{3A74DF2E-6A91-4E63-8FEB-33D3E755AC0A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7" creationId="{A349CC35-B868-4B26-AE87-022E10EE9F37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10" creationId="{1FC9E0B0-3F97-4AEB-B375-7305B25306A0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12" creationId="{0BA3D2AD-B43E-43D0-9ECA-7D952B8DE6E8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13" creationId="{8860B909-B6A4-4AA0-B538-6163788778BE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1" creationId="{989C72CF-7A86-4568-B2D1-8764349B6EDB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2" creationId="{4630C88C-26AD-4076-8DA8-FB9BEC843FF5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3" creationId="{F86BE3AF-1D99-401A-BE42-43B246EDC66C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4" creationId="{0851CF9C-3D61-4168-82D9-51A61F84677C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5" creationId="{BDB21290-D4D9-4BE7-9CA2-E48B590CE490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6" creationId="{C0D8D2F9-996B-45D7-B297-D60EB4630FDF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7" creationId="{1E5BAAA2-0AED-4EE5-BE2E-F8AFB5EDD8DC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8" creationId="{EDB950D3-E16C-49C1-B8DB-641E2C7A85DA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29" creationId="{DAB96302-B3C1-4A44-963C-19BFE5C96544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30" creationId="{4C6C2F79-10A8-4B0A-B00A-D242664EC925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31" creationId="{5E7046AD-0F44-4FFA-B21F-E8285A854E04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32" creationId="{44EDC9B2-32DA-4A6F-A48B-2FBD08958474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39" creationId="{374DC72B-E35F-4201-9336-0205D2B6B583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41" creationId="{7BC9F3DE-F2ED-46B5-A82A-31DFD8831D0A}"/>
          </ac:spMkLst>
        </pc:spChg>
        <pc:spChg chg="add mod">
          <ac:chgData name="Tekle Pauzaite" userId="06f7e524-8501-4f81-9b2a-484f6f2c7061" providerId="ADAL" clId="{960823C5-79AC-4157-BA04-6C8E5D5B9754}" dt="2024-03-26T14:10:23.194" v="3" actId="1076"/>
          <ac:spMkLst>
            <pc:docMk/>
            <pc:sldMk cId="1572326335" sldId="256"/>
            <ac:spMk id="42" creationId="{023DB0F5-43BA-4B9D-9EEF-38BBDD31B709}"/>
          </ac:spMkLst>
        </pc:spChg>
        <pc:spChg chg="add mod">
          <ac:chgData name="Tekle Pauzaite" userId="06f7e524-8501-4f81-9b2a-484f6f2c7061" providerId="ADAL" clId="{960823C5-79AC-4157-BA04-6C8E5D5B9754}" dt="2024-03-26T14:11:28.867" v="29" actId="14100"/>
          <ac:spMkLst>
            <pc:docMk/>
            <pc:sldMk cId="1572326335" sldId="256"/>
            <ac:spMk id="44" creationId="{F5AA1D0B-B592-4ADF-B71A-C725FAC45848}"/>
          </ac:spMkLst>
        </pc:spChg>
        <pc:spChg chg="add mod">
          <ac:chgData name="Tekle Pauzaite" userId="06f7e524-8501-4f81-9b2a-484f6f2c7061" providerId="ADAL" clId="{960823C5-79AC-4157-BA04-6C8E5D5B9754}" dt="2024-03-26T14:12:06.211" v="52" actId="1038"/>
          <ac:spMkLst>
            <pc:docMk/>
            <pc:sldMk cId="1572326335" sldId="256"/>
            <ac:spMk id="46" creationId="{F20058EC-3598-48BE-97D0-8BDF17EF8E33}"/>
          </ac:spMkLst>
        </pc:spChg>
        <pc:spChg chg="add mod">
          <ac:chgData name="Tekle Pauzaite" userId="06f7e524-8501-4f81-9b2a-484f6f2c7061" providerId="ADAL" clId="{960823C5-79AC-4157-BA04-6C8E5D5B9754}" dt="2024-03-26T14:15:52.946" v="75" actId="571"/>
          <ac:spMkLst>
            <pc:docMk/>
            <pc:sldMk cId="1572326335" sldId="256"/>
            <ac:spMk id="48" creationId="{4AB3EAB9-DD1E-4C8A-913E-5CA30A4E3AB8}"/>
          </ac:spMkLst>
        </pc:spChg>
        <pc:spChg chg="add mod">
          <ac:chgData name="Tekle Pauzaite" userId="06f7e524-8501-4f81-9b2a-484f6f2c7061" providerId="ADAL" clId="{960823C5-79AC-4157-BA04-6C8E5D5B9754}" dt="2024-03-26T14:16:11.378" v="77" actId="1076"/>
          <ac:spMkLst>
            <pc:docMk/>
            <pc:sldMk cId="1572326335" sldId="256"/>
            <ac:spMk id="49" creationId="{283B74BC-2CC9-426A-A819-7CDFC5C3E253}"/>
          </ac:spMkLst>
        </pc:spChg>
        <pc:spChg chg="add mod">
          <ac:chgData name="Tekle Pauzaite" userId="06f7e524-8501-4f81-9b2a-484f6f2c7061" providerId="ADAL" clId="{960823C5-79AC-4157-BA04-6C8E5D5B9754}" dt="2024-03-26T14:16:37.730" v="80" actId="571"/>
          <ac:spMkLst>
            <pc:docMk/>
            <pc:sldMk cId="1572326335" sldId="256"/>
            <ac:spMk id="51" creationId="{DB7BBD10-15A4-4F16-AC72-56586583E3FE}"/>
          </ac:spMkLst>
        </pc:spChg>
        <pc:spChg chg="add mod">
          <ac:chgData name="Tekle Pauzaite" userId="06f7e524-8501-4f81-9b2a-484f6f2c7061" providerId="ADAL" clId="{960823C5-79AC-4157-BA04-6C8E5D5B9754}" dt="2024-03-26T14:17:35.434" v="109" actId="1076"/>
          <ac:spMkLst>
            <pc:docMk/>
            <pc:sldMk cId="1572326335" sldId="256"/>
            <ac:spMk id="52" creationId="{A78714F5-14B7-4DDE-A1B6-D83C63D506ED}"/>
          </ac:spMkLst>
        </pc:spChg>
        <pc:spChg chg="add mod">
          <ac:chgData name="Tekle Pauzaite" userId="06f7e524-8501-4f81-9b2a-484f6f2c7061" providerId="ADAL" clId="{960823C5-79AC-4157-BA04-6C8E5D5B9754}" dt="2024-03-26T14:18:08.603" v="129" actId="571"/>
          <ac:spMkLst>
            <pc:docMk/>
            <pc:sldMk cId="1572326335" sldId="256"/>
            <ac:spMk id="54" creationId="{391650A2-1FB2-4CFB-84DF-733972E7E87E}"/>
          </ac:spMkLst>
        </pc:spChg>
        <pc:spChg chg="add mod">
          <ac:chgData name="Tekle Pauzaite" userId="06f7e524-8501-4f81-9b2a-484f6f2c7061" providerId="ADAL" clId="{960823C5-79AC-4157-BA04-6C8E5D5B9754}" dt="2024-03-26T14:18:14.986" v="130" actId="571"/>
          <ac:spMkLst>
            <pc:docMk/>
            <pc:sldMk cId="1572326335" sldId="256"/>
            <ac:spMk id="55" creationId="{1A031F78-F6F1-4B38-9877-09DF071D7A16}"/>
          </ac:spMkLst>
        </pc:spChg>
        <pc:spChg chg="add mod">
          <ac:chgData name="Tekle Pauzaite" userId="06f7e524-8501-4f81-9b2a-484f6f2c7061" providerId="ADAL" clId="{960823C5-79AC-4157-BA04-6C8E5D5B9754}" dt="2024-03-26T14:18:19.146" v="131" actId="571"/>
          <ac:spMkLst>
            <pc:docMk/>
            <pc:sldMk cId="1572326335" sldId="256"/>
            <ac:spMk id="56" creationId="{60743CEB-2E74-43B3-80D5-212DD74895FE}"/>
          </ac:spMkLst>
        </pc:spChg>
        <pc:spChg chg="add mod">
          <ac:chgData name="Tekle Pauzaite" userId="06f7e524-8501-4f81-9b2a-484f6f2c7061" providerId="ADAL" clId="{960823C5-79AC-4157-BA04-6C8E5D5B9754}" dt="2024-03-26T14:18:23.834" v="132" actId="571"/>
          <ac:spMkLst>
            <pc:docMk/>
            <pc:sldMk cId="1572326335" sldId="256"/>
            <ac:spMk id="57" creationId="{C72D7F6F-B5C1-4A63-83CE-9BB675EB2E0C}"/>
          </ac:spMkLst>
        </pc:spChg>
        <pc:spChg chg="add mod">
          <ac:chgData name="Tekle Pauzaite" userId="06f7e524-8501-4f81-9b2a-484f6f2c7061" providerId="ADAL" clId="{960823C5-79AC-4157-BA04-6C8E5D5B9754}" dt="2024-03-26T14:18:28.282" v="133" actId="571"/>
          <ac:spMkLst>
            <pc:docMk/>
            <pc:sldMk cId="1572326335" sldId="256"/>
            <ac:spMk id="58" creationId="{B7345CAC-6540-46E3-A0EC-EF684FF4888C}"/>
          </ac:spMkLst>
        </pc:spChg>
        <pc:spChg chg="add mod">
          <ac:chgData name="Tekle Pauzaite" userId="06f7e524-8501-4f81-9b2a-484f6f2c7061" providerId="ADAL" clId="{960823C5-79AC-4157-BA04-6C8E5D5B9754}" dt="2024-03-26T14:18:33.362" v="134" actId="571"/>
          <ac:spMkLst>
            <pc:docMk/>
            <pc:sldMk cId="1572326335" sldId="256"/>
            <ac:spMk id="59" creationId="{C3741561-31F8-4C05-B32A-00C04720B049}"/>
          </ac:spMkLst>
        </pc:spChg>
        <pc:spChg chg="add mod">
          <ac:chgData name="Tekle Pauzaite" userId="06f7e524-8501-4f81-9b2a-484f6f2c7061" providerId="ADAL" clId="{960823C5-79AC-4157-BA04-6C8E5D5B9754}" dt="2024-03-26T14:18:38.786" v="135" actId="571"/>
          <ac:spMkLst>
            <pc:docMk/>
            <pc:sldMk cId="1572326335" sldId="256"/>
            <ac:spMk id="60" creationId="{BDCA704D-E970-45D7-B8E2-2A4768761133}"/>
          </ac:spMkLst>
        </pc:spChg>
        <pc:spChg chg="add mod">
          <ac:chgData name="Tekle Pauzaite" userId="06f7e524-8501-4f81-9b2a-484f6f2c7061" providerId="ADAL" clId="{960823C5-79AC-4157-BA04-6C8E5D5B9754}" dt="2024-03-26T14:18:42.186" v="136" actId="571"/>
          <ac:spMkLst>
            <pc:docMk/>
            <pc:sldMk cId="1572326335" sldId="256"/>
            <ac:spMk id="61" creationId="{3B781EDF-0122-497B-B691-FEFD32EEAF1A}"/>
          </ac:spMkLst>
        </pc:sp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4" creationId="{EE2316DE-BF79-4319-829E-18EDA7945E76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5" creationId="{B03AE02D-5CEE-4398-AF89-1F392ED56B65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6" creationId="{DC711D32-F4B7-4462-AF2F-E1A8B7464BA4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7" creationId="{510265C3-0FB7-44FE-8E86-AF793FFEB490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8" creationId="{86401400-A507-4C46-BE47-2443020AE6B6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19" creationId="{D032A7C3-7461-42D7-A746-2054202602A4}"/>
          </ac:picMkLst>
        </pc:picChg>
        <pc:picChg chg="add mod">
          <ac:chgData name="Tekle Pauzaite" userId="06f7e524-8501-4f81-9b2a-484f6f2c7061" providerId="ADAL" clId="{960823C5-79AC-4157-BA04-6C8E5D5B9754}" dt="2024-03-26T14:10:23.194" v="3" actId="1076"/>
          <ac:picMkLst>
            <pc:docMk/>
            <pc:sldMk cId="1572326335" sldId="256"/>
            <ac:picMk id="20" creationId="{3A9B1ACB-2CA9-462A-B1FE-48A72DCDCDC9}"/>
          </ac:picMkLst>
        </pc:picChg>
        <pc:picChg chg="add mod modCrop">
          <ac:chgData name="Tekle Pauzaite" userId="06f7e524-8501-4f81-9b2a-484f6f2c7061" providerId="ADAL" clId="{960823C5-79AC-4157-BA04-6C8E5D5B9754}" dt="2024-03-26T14:11:07.498" v="25" actId="1076"/>
          <ac:picMkLst>
            <pc:docMk/>
            <pc:sldMk cId="1572326335" sldId="256"/>
            <ac:picMk id="43" creationId="{E05665F7-418E-4E95-B8AD-51182C57E679}"/>
          </ac:picMkLst>
        </pc:picChg>
        <pc:picChg chg="add mod modCrop">
          <ac:chgData name="Tekle Pauzaite" userId="06f7e524-8501-4f81-9b2a-484f6f2c7061" providerId="ADAL" clId="{960823C5-79AC-4157-BA04-6C8E5D5B9754}" dt="2024-03-26T14:11:56.722" v="48" actId="1076"/>
          <ac:picMkLst>
            <pc:docMk/>
            <pc:sldMk cId="1572326335" sldId="256"/>
            <ac:picMk id="45" creationId="{6851E5E6-25B1-43EF-AF62-99378A1BAAF2}"/>
          </ac:picMkLst>
        </pc:picChg>
        <pc:picChg chg="add mod modCrop">
          <ac:chgData name="Tekle Pauzaite" userId="06f7e524-8501-4f81-9b2a-484f6f2c7061" providerId="ADAL" clId="{960823C5-79AC-4157-BA04-6C8E5D5B9754}" dt="2024-03-26T14:15:41.289" v="74" actId="1076"/>
          <ac:picMkLst>
            <pc:docMk/>
            <pc:sldMk cId="1572326335" sldId="256"/>
            <ac:picMk id="47" creationId="{FD1F1C64-72DE-4870-948D-C265DB6CD934}"/>
          </ac:picMkLst>
        </pc:picChg>
        <pc:picChg chg="add mod modCrop">
          <ac:chgData name="Tekle Pauzaite" userId="06f7e524-8501-4f81-9b2a-484f6f2c7061" providerId="ADAL" clId="{960823C5-79AC-4157-BA04-6C8E5D5B9754}" dt="2024-03-26T14:17:25.714" v="107" actId="1076"/>
          <ac:picMkLst>
            <pc:docMk/>
            <pc:sldMk cId="1572326335" sldId="256"/>
            <ac:picMk id="50" creationId="{4CD88E15-B95A-45F5-B663-6267C8604330}"/>
          </ac:picMkLst>
        </pc:picChg>
        <pc:picChg chg="add mod modCrop">
          <ac:chgData name="Tekle Pauzaite" userId="06f7e524-8501-4f81-9b2a-484f6f2c7061" providerId="ADAL" clId="{960823C5-79AC-4157-BA04-6C8E5D5B9754}" dt="2024-03-26T14:18:04.714" v="128" actId="1076"/>
          <ac:picMkLst>
            <pc:docMk/>
            <pc:sldMk cId="1572326335" sldId="256"/>
            <ac:picMk id="53" creationId="{FD15693A-44F9-469B-8EF3-E1D31901DE5C}"/>
          </ac:picMkLst>
        </pc:pic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8" creationId="{CE41B1D4-7AE9-46DA-B7B9-F035C76B5B92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9" creationId="{FE967740-B7D7-4D10-86EB-4CE11838904D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11" creationId="{D547DEC9-C9A4-4294-AEE1-8D700191B00E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3" creationId="{124B5863-CA7C-4D9C-B273-E6A3AC318F28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4" creationId="{35103E10-8D61-4F0F-B367-06A289C5A414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5" creationId="{13ED3644-E31A-47B5-9E6F-8AFC7E426B93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6" creationId="{1BA33F1D-D3AA-45B9-B76E-EAD7FEAF88CD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7" creationId="{341B4277-8FB3-4080-9B6D-DC8A2F556725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38" creationId="{13E28478-8696-46B0-82CF-2AE1F74257DE}"/>
          </ac:cxnSpMkLst>
        </pc:cxnChg>
        <pc:cxnChg chg="add mod">
          <ac:chgData name="Tekle Pauzaite" userId="06f7e524-8501-4f81-9b2a-484f6f2c7061" providerId="ADAL" clId="{960823C5-79AC-4157-BA04-6C8E5D5B9754}" dt="2024-03-26T14:10:23.194" v="3" actId="1076"/>
          <ac:cxnSpMkLst>
            <pc:docMk/>
            <pc:sldMk cId="1572326335" sldId="256"/>
            <ac:cxnSpMk id="40" creationId="{BA2F7E98-3E70-4717-A192-D65C2A75EC2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B7A6D-A17C-4E96-AA76-93A4E76ABA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99B4AB-ED59-41B1-8DA0-CB978B5C21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B6460A-E765-47C9-B8F3-2536FD0A4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18663-0C70-4083-9FFA-779B9DE18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BDFFBA-C0CE-40B0-940E-AC21BC898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5882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15B54-D8D5-4D4C-9A3D-B5C3D51D1F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45A54E-2F4A-4DA7-A1E9-C2D536046F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7A2A7C-6950-4C14-A99B-8DBBAF272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0E718-E236-4229-BDD4-E5643DBAD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A09C29-CF27-47D3-8C95-40D0615F5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9804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C281FE-3C52-4687-9F02-B4DC42952E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C79940-9BFB-4DD9-9639-484982B305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48C343-F055-4B73-89DA-E8E67299D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B44D3-F88C-421D-9745-19D03182B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232A4-9146-4E86-BA2D-0EE9E9193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846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1A915F-F3A0-4EBD-8DC1-99B992CF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519D88-98EF-4AC1-A9BA-ED1F4A8490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2DDB3D-9CC2-4076-93F9-13F285686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3CCC7-BA00-4096-A7B5-70B18391A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4C8C2C-FA41-46C4-BE6E-304200554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2252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CFED5-DF3D-4B5A-B68B-984A940C9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799A69-8A98-4B3E-9482-017130DE77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6656FF-8029-45E4-B17E-A8A412D67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66AD2E-5B04-4FF4-BD9C-C9FF64D6E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6C3CB1-C83F-4080-9428-123237579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4830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0ABEE-09C8-43BC-B19A-5E0434F1C8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6A2D86-98D8-41BA-82CC-AE7CBA3FED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24F05B-634D-4E5A-A7F4-3C4A36348F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17D7B0-E369-44E1-91C6-58CB82E63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57ED76-181F-410B-9FE7-67D407452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9B37DE-58E2-48B4-9038-592CA5014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359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1BAEC-3DDA-4B2A-89ED-0A0BDB1E65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FE0865-BE33-46AE-8E9F-59348AD7EC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65C59A-9A9F-440D-9C2C-C12F91A73C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4429BD0-CEAD-4ABA-971A-CCAA684B63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E25B24-2373-494D-B0C4-846DC6B903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34E44D-CFE2-481D-8925-03D17EC9F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92607DE-9A9D-4E30-8A82-0BC7FECFD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8F7209-DC34-4768-A9B6-9DC7EA845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504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20615-8CCA-4DDE-98C2-2F92327988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8E7E66-649E-44CF-87D5-BBE70C6BEC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1EB682-ED18-433C-B424-F1FAACA99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974AED-3960-4AA3-AADE-BA7384FD8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335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281C3F-685C-4148-B880-A6B172778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C68EEF-0D80-4296-8EC6-4210C2B80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1CC232-EB78-457F-9341-0BB5A28DA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53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46AA0C-2FBA-475F-B2F8-6F58C9545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7C6415-B7FC-4A0F-815F-46F4654991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A93313-DE4E-46FD-B498-5C4CBED2F7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F71AE2-5450-45D0-A58E-64FC0DE8F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1BED36-719E-4C04-B32E-7112D464A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6849D4-1F31-4036-996C-D1F6945AC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3487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D582AE-0C53-409C-ADB5-F0C8F6153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8448D-55E9-4D66-889C-39C5E60943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F22440-0344-48DA-A279-9B9CE0DCD0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6D045A-48FC-487A-A0F8-139E56F6B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C5B1B-883F-489C-9A69-14B429612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4BFD68-9F90-4E94-8A21-EE395F37B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0891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F2A576-BFA3-4EC3-B858-14B3B7CCE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C3FBFD-E07B-4037-ABA8-9096A05F0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A540B-D82B-45EB-AEBA-B0BAAC0BBA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CEB5C-85A7-4652-BFD8-269F8B305FEB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5249E5-AA82-4711-91CA-1EADC2414F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5B934B-7D81-4C23-8907-3243EAFBD9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3F6C5-5A33-4BF9-88A1-938895B0AB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542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F92CD2F-50F4-4CC8-9DCB-BC0ED022E07E}"/>
              </a:ext>
            </a:extLst>
          </p:cNvPr>
          <p:cNvSpPr txBox="1"/>
          <p:nvPr/>
        </p:nvSpPr>
        <p:spPr>
          <a:xfrm>
            <a:off x="117500" y="27047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TextBox 14">
            <a:extLst>
              <a:ext uri="{FF2B5EF4-FFF2-40B4-BE49-F238E27FC236}">
                <a16:creationId xmlns:a16="http://schemas.microsoft.com/office/drawing/2014/main" id="{0CE59D3F-E750-422A-B1C8-11567EC8BB38}"/>
              </a:ext>
            </a:extLst>
          </p:cNvPr>
          <p:cNvSpPr txBox="1"/>
          <p:nvPr/>
        </p:nvSpPr>
        <p:spPr>
          <a:xfrm>
            <a:off x="556460" y="215046"/>
            <a:ext cx="560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MSO 21 %</a:t>
            </a:r>
          </a:p>
        </p:txBody>
      </p:sp>
      <p:sp>
        <p:nvSpPr>
          <p:cNvPr id="6" name="TextBox 15">
            <a:extLst>
              <a:ext uri="{FF2B5EF4-FFF2-40B4-BE49-F238E27FC236}">
                <a16:creationId xmlns:a16="http://schemas.microsoft.com/office/drawing/2014/main" id="{3A74DF2E-6A91-4E63-8FEB-33D3E755AC0A}"/>
              </a:ext>
            </a:extLst>
          </p:cNvPr>
          <p:cNvSpPr txBox="1"/>
          <p:nvPr/>
        </p:nvSpPr>
        <p:spPr>
          <a:xfrm>
            <a:off x="1298420" y="352228"/>
            <a:ext cx="639290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MOG</a:t>
            </a:r>
          </a:p>
        </p:txBody>
      </p:sp>
      <p:sp>
        <p:nvSpPr>
          <p:cNvPr id="7" name="TextBox 16">
            <a:extLst>
              <a:ext uri="{FF2B5EF4-FFF2-40B4-BE49-F238E27FC236}">
                <a16:creationId xmlns:a16="http://schemas.microsoft.com/office/drawing/2014/main" id="{A349CC35-B868-4B26-AE87-022E10EE9F37}"/>
              </a:ext>
            </a:extLst>
          </p:cNvPr>
          <p:cNvSpPr txBox="1"/>
          <p:nvPr/>
        </p:nvSpPr>
        <p:spPr>
          <a:xfrm>
            <a:off x="615783" y="2990427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E41B1D4-7AE9-46DA-B7B9-F035C76B5B92}"/>
              </a:ext>
            </a:extLst>
          </p:cNvPr>
          <p:cNvCxnSpPr>
            <a:cxnSpLocks/>
          </p:cNvCxnSpPr>
          <p:nvPr/>
        </p:nvCxnSpPr>
        <p:spPr>
          <a:xfrm>
            <a:off x="693693" y="572588"/>
            <a:ext cx="3028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E967740-B7D7-4D10-86EB-4CE11838904D}"/>
              </a:ext>
            </a:extLst>
          </p:cNvPr>
          <p:cNvCxnSpPr>
            <a:cxnSpLocks/>
          </p:cNvCxnSpPr>
          <p:nvPr/>
        </p:nvCxnSpPr>
        <p:spPr>
          <a:xfrm>
            <a:off x="1047690" y="572588"/>
            <a:ext cx="3028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4">
            <a:extLst>
              <a:ext uri="{FF2B5EF4-FFF2-40B4-BE49-F238E27FC236}">
                <a16:creationId xmlns:a16="http://schemas.microsoft.com/office/drawing/2014/main" id="{1FC9E0B0-3F97-4AEB-B375-7305B25306A0}"/>
              </a:ext>
            </a:extLst>
          </p:cNvPr>
          <p:cNvSpPr txBox="1"/>
          <p:nvPr/>
        </p:nvSpPr>
        <p:spPr>
          <a:xfrm>
            <a:off x="940065" y="215046"/>
            <a:ext cx="538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MSO 1 %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547DEC9-C9A4-4294-AEE1-8D700191B00E}"/>
              </a:ext>
            </a:extLst>
          </p:cNvPr>
          <p:cNvCxnSpPr>
            <a:cxnSpLocks/>
          </p:cNvCxnSpPr>
          <p:nvPr/>
        </p:nvCxnSpPr>
        <p:spPr>
          <a:xfrm>
            <a:off x="1401687" y="572588"/>
            <a:ext cx="3028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32">
            <a:extLst>
              <a:ext uri="{FF2B5EF4-FFF2-40B4-BE49-F238E27FC236}">
                <a16:creationId xmlns:a16="http://schemas.microsoft.com/office/drawing/2014/main" id="{0BA3D2AD-B43E-43D0-9ECA-7D952B8DE6E8}"/>
              </a:ext>
            </a:extLst>
          </p:cNvPr>
          <p:cNvSpPr txBox="1"/>
          <p:nvPr/>
        </p:nvSpPr>
        <p:spPr>
          <a:xfrm>
            <a:off x="1791549" y="2742768"/>
            <a:ext cx="409724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13" name="TextBox 33">
            <a:extLst>
              <a:ext uri="{FF2B5EF4-FFF2-40B4-BE49-F238E27FC236}">
                <a16:creationId xmlns:a16="http://schemas.microsoft.com/office/drawing/2014/main" id="{8860B909-B6A4-4AA0-B538-6163788778BE}"/>
              </a:ext>
            </a:extLst>
          </p:cNvPr>
          <p:cNvSpPr txBox="1"/>
          <p:nvPr/>
        </p:nvSpPr>
        <p:spPr>
          <a:xfrm>
            <a:off x="1789064" y="1158224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E2316DE-BF79-4319-829E-18EDA7945E7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66" t="57202" r="33267" b="28514"/>
          <a:stretch/>
        </p:blipFill>
        <p:spPr>
          <a:xfrm rot="16200000">
            <a:off x="1103173" y="702394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03AE02D-5CEE-4398-AF89-1F392ED56B6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505" t="56862" r="44913" b="29389"/>
          <a:stretch/>
        </p:blipFill>
        <p:spPr>
          <a:xfrm rot="16200000">
            <a:off x="1103173" y="1649770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C711D32-F4B7-4462-AF2F-E1A8B7464BA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73" t="56530" r="28255" b="28217"/>
          <a:stretch/>
        </p:blipFill>
        <p:spPr>
          <a:xfrm rot="16200000">
            <a:off x="1103173" y="386603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10265C3-0FB7-44FE-8E86-AF793FFEB49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99" t="55805" r="47836" b="29849"/>
          <a:stretch/>
        </p:blipFill>
        <p:spPr>
          <a:xfrm rot="16200000">
            <a:off x="1103173" y="2281355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6401400-A507-4C46-BE47-2443020AE6B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778" t="54748" r="36928" b="31366"/>
          <a:stretch/>
        </p:blipFill>
        <p:spPr>
          <a:xfrm rot="16200000">
            <a:off x="1103173" y="1333978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032A7C3-7461-42D7-A746-2054202602A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422" t="70748" r="35284" b="15366"/>
          <a:stretch/>
        </p:blipFill>
        <p:spPr>
          <a:xfrm rot="16200000">
            <a:off x="1103173" y="1018186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A9B1ACB-2CA9-462A-B1FE-48A72DCDCDC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596" t="54821" r="49110" b="31293"/>
          <a:stretch/>
        </p:blipFill>
        <p:spPr>
          <a:xfrm rot="16200000">
            <a:off x="1103173" y="1965562"/>
            <a:ext cx="277105" cy="11084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TextBox 33">
            <a:extLst>
              <a:ext uri="{FF2B5EF4-FFF2-40B4-BE49-F238E27FC236}">
                <a16:creationId xmlns:a16="http://schemas.microsoft.com/office/drawing/2014/main" id="{989C72CF-7A86-4568-B2D1-8764349B6EDB}"/>
              </a:ext>
            </a:extLst>
          </p:cNvPr>
          <p:cNvSpPr txBox="1"/>
          <p:nvPr/>
        </p:nvSpPr>
        <p:spPr>
          <a:xfrm>
            <a:off x="1796692" y="1455043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33">
            <a:extLst>
              <a:ext uri="{FF2B5EF4-FFF2-40B4-BE49-F238E27FC236}">
                <a16:creationId xmlns:a16="http://schemas.microsoft.com/office/drawing/2014/main" id="{4630C88C-26AD-4076-8DA8-FB9BEC843FF5}"/>
              </a:ext>
            </a:extLst>
          </p:cNvPr>
          <p:cNvSpPr txBox="1"/>
          <p:nvPr/>
        </p:nvSpPr>
        <p:spPr>
          <a:xfrm>
            <a:off x="1796692" y="1790966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33">
            <a:extLst>
              <a:ext uri="{FF2B5EF4-FFF2-40B4-BE49-F238E27FC236}">
                <a16:creationId xmlns:a16="http://schemas.microsoft.com/office/drawing/2014/main" id="{F86BE3AF-1D99-401A-BE42-43B246EDC66C}"/>
              </a:ext>
            </a:extLst>
          </p:cNvPr>
          <p:cNvSpPr txBox="1"/>
          <p:nvPr/>
        </p:nvSpPr>
        <p:spPr>
          <a:xfrm>
            <a:off x="1796690" y="2469393"/>
            <a:ext cx="369979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24" name="TextBox 28">
            <a:extLst>
              <a:ext uri="{FF2B5EF4-FFF2-40B4-BE49-F238E27FC236}">
                <a16:creationId xmlns:a16="http://schemas.microsoft.com/office/drawing/2014/main" id="{0851CF9C-3D61-4168-82D9-51A61F84677C}"/>
              </a:ext>
            </a:extLst>
          </p:cNvPr>
          <p:cNvSpPr txBox="1"/>
          <p:nvPr/>
        </p:nvSpPr>
        <p:spPr>
          <a:xfrm>
            <a:off x="1801184" y="835774"/>
            <a:ext cx="5575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5" name="TextBox 30">
            <a:extLst>
              <a:ext uri="{FF2B5EF4-FFF2-40B4-BE49-F238E27FC236}">
                <a16:creationId xmlns:a16="http://schemas.microsoft.com/office/drawing/2014/main" id="{BDB21290-D4D9-4BE7-9CA2-E48B590CE490}"/>
              </a:ext>
            </a:extLst>
          </p:cNvPr>
          <p:cNvSpPr txBox="1"/>
          <p:nvPr/>
        </p:nvSpPr>
        <p:spPr>
          <a:xfrm>
            <a:off x="1803669" y="2107029"/>
            <a:ext cx="405322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0D8D2F9-996B-45D7-B297-D60EB4630FDF}"/>
              </a:ext>
            </a:extLst>
          </p:cNvPr>
          <p:cNvSpPr txBox="1"/>
          <p:nvPr/>
        </p:nvSpPr>
        <p:spPr>
          <a:xfrm>
            <a:off x="310650" y="796902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E5BAAA2-0AED-4EE5-BE2E-F8AFB5EDD8DC}"/>
              </a:ext>
            </a:extLst>
          </p:cNvPr>
          <p:cNvSpPr txBox="1"/>
          <p:nvPr/>
        </p:nvSpPr>
        <p:spPr>
          <a:xfrm>
            <a:off x="358825" y="116442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DB950D3-E16C-49C1-B8DB-641E2C7A85DA}"/>
              </a:ext>
            </a:extLst>
          </p:cNvPr>
          <p:cNvSpPr txBox="1"/>
          <p:nvPr/>
        </p:nvSpPr>
        <p:spPr>
          <a:xfrm>
            <a:off x="358825" y="2176900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AB96302-B3C1-4A44-963C-19BFE5C96544}"/>
              </a:ext>
            </a:extLst>
          </p:cNvPr>
          <p:cNvSpPr txBox="1"/>
          <p:nvPr/>
        </p:nvSpPr>
        <p:spPr>
          <a:xfrm>
            <a:off x="307808" y="603290"/>
            <a:ext cx="2929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C6C2F79-10A8-4B0A-B00A-D242664EC925}"/>
              </a:ext>
            </a:extLst>
          </p:cNvPr>
          <p:cNvSpPr txBox="1"/>
          <p:nvPr/>
        </p:nvSpPr>
        <p:spPr>
          <a:xfrm>
            <a:off x="358825" y="145710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E7046AD-0F44-4FFA-B21F-E8285A854E04}"/>
              </a:ext>
            </a:extLst>
          </p:cNvPr>
          <p:cNvSpPr txBox="1"/>
          <p:nvPr/>
        </p:nvSpPr>
        <p:spPr>
          <a:xfrm>
            <a:off x="358825" y="1785264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4EDC9B2-32DA-4A6F-A48B-2FBD08958474}"/>
              </a:ext>
            </a:extLst>
          </p:cNvPr>
          <p:cNvSpPr txBox="1"/>
          <p:nvPr/>
        </p:nvSpPr>
        <p:spPr>
          <a:xfrm>
            <a:off x="358825" y="245185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24B5863-CA7C-4D9C-B273-E6A3AC318F28}"/>
              </a:ext>
            </a:extLst>
          </p:cNvPr>
          <p:cNvCxnSpPr/>
          <p:nvPr/>
        </p:nvCxnSpPr>
        <p:spPr>
          <a:xfrm>
            <a:off x="612105" y="91453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5103E10-8D61-4F0F-B367-06A289C5A414}"/>
              </a:ext>
            </a:extLst>
          </p:cNvPr>
          <p:cNvCxnSpPr/>
          <p:nvPr/>
        </p:nvCxnSpPr>
        <p:spPr>
          <a:xfrm>
            <a:off x="612105" y="127475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3ED3644-E31A-47B5-9E6F-8AFC7E426B93}"/>
              </a:ext>
            </a:extLst>
          </p:cNvPr>
          <p:cNvCxnSpPr/>
          <p:nvPr/>
        </p:nvCxnSpPr>
        <p:spPr>
          <a:xfrm>
            <a:off x="612105" y="156847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BA33F1D-D3AA-45B9-B76E-EAD7FEAF88CD}"/>
              </a:ext>
            </a:extLst>
          </p:cNvPr>
          <p:cNvCxnSpPr/>
          <p:nvPr/>
        </p:nvCxnSpPr>
        <p:spPr>
          <a:xfrm>
            <a:off x="612105" y="190502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41B4277-8FB3-4080-9B6D-DC8A2F556725}"/>
              </a:ext>
            </a:extLst>
          </p:cNvPr>
          <p:cNvCxnSpPr/>
          <p:nvPr/>
        </p:nvCxnSpPr>
        <p:spPr>
          <a:xfrm>
            <a:off x="612105" y="228919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3E28478-8696-46B0-82CF-2AE1F74257DE}"/>
              </a:ext>
            </a:extLst>
          </p:cNvPr>
          <p:cNvCxnSpPr/>
          <p:nvPr/>
        </p:nvCxnSpPr>
        <p:spPr>
          <a:xfrm>
            <a:off x="612105" y="256542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374DC72B-E35F-4201-9336-0205D2B6B583}"/>
              </a:ext>
            </a:extLst>
          </p:cNvPr>
          <p:cNvSpPr txBox="1"/>
          <p:nvPr/>
        </p:nvSpPr>
        <p:spPr>
          <a:xfrm>
            <a:off x="360091" y="275593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A2F7E98-3E70-4717-A192-D65C2A75EC2C}"/>
              </a:ext>
            </a:extLst>
          </p:cNvPr>
          <p:cNvCxnSpPr/>
          <p:nvPr/>
        </p:nvCxnSpPr>
        <p:spPr>
          <a:xfrm>
            <a:off x="613371" y="286950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16">
            <a:extLst>
              <a:ext uri="{FF2B5EF4-FFF2-40B4-BE49-F238E27FC236}">
                <a16:creationId xmlns:a16="http://schemas.microsoft.com/office/drawing/2014/main" id="{7BC9F3DE-F2ED-46B5-A82A-31DFD8831D0A}"/>
              </a:ext>
            </a:extLst>
          </p:cNvPr>
          <p:cNvSpPr txBox="1"/>
          <p:nvPr/>
        </p:nvSpPr>
        <p:spPr>
          <a:xfrm>
            <a:off x="1801184" y="584585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23DB0F5-43BA-4B9D-9EEF-38BBDD31B709}"/>
              </a:ext>
            </a:extLst>
          </p:cNvPr>
          <p:cNvSpPr txBox="1"/>
          <p:nvPr/>
        </p:nvSpPr>
        <p:spPr>
          <a:xfrm>
            <a:off x="692278" y="584585"/>
            <a:ext cx="11161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    +    -    +    -   + 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E05665F7-418E-4E95-B8AD-51182C57E67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" t="-191" r="-445" b="-110"/>
          <a:stretch/>
        </p:blipFill>
        <p:spPr>
          <a:xfrm rot="16200000">
            <a:off x="3901024" y="-661958"/>
            <a:ext cx="2098044" cy="41142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F5AA1D0B-B592-4ADF-B71A-C725FAC45848}"/>
              </a:ext>
            </a:extLst>
          </p:cNvPr>
          <p:cNvSpPr/>
          <p:nvPr/>
        </p:nvSpPr>
        <p:spPr>
          <a:xfrm>
            <a:off x="5189220" y="914529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6851E5E6-25B1-43EF-AF62-99378A1BAAF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6" t="422" r="201" b="400"/>
          <a:stretch/>
        </p:blipFill>
        <p:spPr>
          <a:xfrm rot="16200000">
            <a:off x="8343758" y="-776995"/>
            <a:ext cx="2127968" cy="43443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F20058EC-3598-48BE-97D0-8BDF17EF8E33}"/>
              </a:ext>
            </a:extLst>
          </p:cNvPr>
          <p:cNvSpPr/>
          <p:nvPr/>
        </p:nvSpPr>
        <p:spPr>
          <a:xfrm>
            <a:off x="9707880" y="1022237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FD1F1C64-72DE-4870-948D-C265DB6CD93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7" t="343" r="383" b="-362"/>
          <a:stretch/>
        </p:blipFill>
        <p:spPr>
          <a:xfrm rot="16200000">
            <a:off x="3894462" y="1525019"/>
            <a:ext cx="2128417" cy="40969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4AB3EAB9-DD1E-4C8A-913E-5CA30A4E3AB8}"/>
              </a:ext>
            </a:extLst>
          </p:cNvPr>
          <p:cNvSpPr/>
          <p:nvPr/>
        </p:nvSpPr>
        <p:spPr>
          <a:xfrm>
            <a:off x="5772150" y="3229083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83B74BC-2CC9-426A-A819-7CDFC5C3E253}"/>
              </a:ext>
            </a:extLst>
          </p:cNvPr>
          <p:cNvSpPr/>
          <p:nvPr/>
        </p:nvSpPr>
        <p:spPr>
          <a:xfrm>
            <a:off x="5076546" y="3229083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4CD88E15-B95A-45F5-B663-6267C860433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6" t="-90" r="-593" b="17"/>
          <a:stretch/>
        </p:blipFill>
        <p:spPr>
          <a:xfrm rot="16200000">
            <a:off x="8276860" y="1570186"/>
            <a:ext cx="2261763" cy="41399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DB7BBD10-15A4-4F16-AC72-56586583E3FE}"/>
              </a:ext>
            </a:extLst>
          </p:cNvPr>
          <p:cNvSpPr/>
          <p:nvPr/>
        </p:nvSpPr>
        <p:spPr>
          <a:xfrm>
            <a:off x="5076546" y="3494122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78714F5-14B7-4DDE-A1B6-D83C63D506ED}"/>
              </a:ext>
            </a:extLst>
          </p:cNvPr>
          <p:cNvSpPr/>
          <p:nvPr/>
        </p:nvSpPr>
        <p:spPr>
          <a:xfrm>
            <a:off x="9629775" y="3551271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FD15693A-44F9-469B-8EF3-E1D31901DE5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9" t="789" r="453" b="958"/>
          <a:stretch/>
        </p:blipFill>
        <p:spPr>
          <a:xfrm rot="16200000">
            <a:off x="3825183" y="3407866"/>
            <a:ext cx="2249728" cy="42851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Rectangle 53">
            <a:extLst>
              <a:ext uri="{FF2B5EF4-FFF2-40B4-BE49-F238E27FC236}">
                <a16:creationId xmlns:a16="http://schemas.microsoft.com/office/drawing/2014/main" id="{391650A2-1FB2-4CFB-84DF-733972E7E87E}"/>
              </a:ext>
            </a:extLst>
          </p:cNvPr>
          <p:cNvSpPr/>
          <p:nvPr/>
        </p:nvSpPr>
        <p:spPr>
          <a:xfrm>
            <a:off x="5189220" y="5510361"/>
            <a:ext cx="647700" cy="199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TextBox 28">
            <a:extLst>
              <a:ext uri="{FF2B5EF4-FFF2-40B4-BE49-F238E27FC236}">
                <a16:creationId xmlns:a16="http://schemas.microsoft.com/office/drawing/2014/main" id="{1A031F78-F6F1-4B38-9877-09DF071D7A16}"/>
              </a:ext>
            </a:extLst>
          </p:cNvPr>
          <p:cNvSpPr txBox="1"/>
          <p:nvPr/>
        </p:nvSpPr>
        <p:spPr>
          <a:xfrm>
            <a:off x="5234287" y="1122195"/>
            <a:ext cx="5575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6" name="TextBox 33">
            <a:extLst>
              <a:ext uri="{FF2B5EF4-FFF2-40B4-BE49-F238E27FC236}">
                <a16:creationId xmlns:a16="http://schemas.microsoft.com/office/drawing/2014/main" id="{60743CEB-2E74-43B3-80D5-212DD74895FE}"/>
              </a:ext>
            </a:extLst>
          </p:cNvPr>
          <p:cNvSpPr txBox="1"/>
          <p:nvPr/>
        </p:nvSpPr>
        <p:spPr>
          <a:xfrm>
            <a:off x="9750570" y="813632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33">
            <a:extLst>
              <a:ext uri="{FF2B5EF4-FFF2-40B4-BE49-F238E27FC236}">
                <a16:creationId xmlns:a16="http://schemas.microsoft.com/office/drawing/2014/main" id="{C72D7F6F-B5C1-4A63-83CE-9BB675EB2E0C}"/>
              </a:ext>
            </a:extLst>
          </p:cNvPr>
          <p:cNvSpPr txBox="1"/>
          <p:nvPr/>
        </p:nvSpPr>
        <p:spPr>
          <a:xfrm>
            <a:off x="5892945" y="3002075"/>
            <a:ext cx="40611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33">
            <a:extLst>
              <a:ext uri="{FF2B5EF4-FFF2-40B4-BE49-F238E27FC236}">
                <a16:creationId xmlns:a16="http://schemas.microsoft.com/office/drawing/2014/main" id="{B7345CAC-6540-46E3-A0EC-EF684FF4888C}"/>
              </a:ext>
            </a:extLst>
          </p:cNvPr>
          <p:cNvSpPr txBox="1"/>
          <p:nvPr/>
        </p:nvSpPr>
        <p:spPr>
          <a:xfrm>
            <a:off x="5167469" y="3013722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30">
            <a:extLst>
              <a:ext uri="{FF2B5EF4-FFF2-40B4-BE49-F238E27FC236}">
                <a16:creationId xmlns:a16="http://schemas.microsoft.com/office/drawing/2014/main" id="{C3741561-31F8-4C05-B32A-00C04720B049}"/>
              </a:ext>
            </a:extLst>
          </p:cNvPr>
          <p:cNvSpPr txBox="1"/>
          <p:nvPr/>
        </p:nvSpPr>
        <p:spPr>
          <a:xfrm>
            <a:off x="9713874" y="3801592"/>
            <a:ext cx="405322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0" name="TextBox 33">
            <a:extLst>
              <a:ext uri="{FF2B5EF4-FFF2-40B4-BE49-F238E27FC236}">
                <a16:creationId xmlns:a16="http://schemas.microsoft.com/office/drawing/2014/main" id="{BDCA704D-E970-45D7-B8E2-2A4768761133}"/>
              </a:ext>
            </a:extLst>
          </p:cNvPr>
          <p:cNvSpPr txBox="1"/>
          <p:nvPr/>
        </p:nvSpPr>
        <p:spPr>
          <a:xfrm>
            <a:off x="5167469" y="3718806"/>
            <a:ext cx="369979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PHD2</a:t>
            </a:r>
          </a:p>
        </p:txBody>
      </p:sp>
      <p:sp>
        <p:nvSpPr>
          <p:cNvPr id="61" name="TextBox 32">
            <a:extLst>
              <a:ext uri="{FF2B5EF4-FFF2-40B4-BE49-F238E27FC236}">
                <a16:creationId xmlns:a16="http://schemas.microsoft.com/office/drawing/2014/main" id="{3B781EDF-0122-497B-B691-FEFD32EEAF1A}"/>
              </a:ext>
            </a:extLst>
          </p:cNvPr>
          <p:cNvSpPr txBox="1"/>
          <p:nvPr/>
        </p:nvSpPr>
        <p:spPr>
          <a:xfrm>
            <a:off x="5308208" y="5738763"/>
            <a:ext cx="409724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572326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6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3-26T14:10:14Z</dcterms:created>
  <dcterms:modified xsi:type="dcterms:W3CDTF">2024-03-26T14:18:45Z</dcterms:modified>
</cp:coreProperties>
</file>